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90FB3-9FD1-4DC3-AE55-5779307012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3288B-1625-4724-927C-312D57965E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9FC4A-500C-498D-A77B-E23EB6008B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C0E1D-4BF0-4DD7-A652-D05A88E978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53F34-ECFC-4150-AED9-0A1EE187B9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1C564-D8AE-42E7-BF9F-4709B6B66B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EE588-F41B-4693-B54B-06CA5CF890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65264-14C3-40C1-A028-6146C7557E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62DB0-2B4A-4B3D-AADF-15A38299CE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DB252-7D72-4760-B54B-9F27EA17D9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0A787-A718-4970-8CF7-107FC10FF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A48FF-1542-4235-852F-763598839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8D82D0-2162-42C1-80EE-4821AAE028B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5717" t="0" r="0" b="0"/>
          <a:stretch/>
        </p:blipFill>
        <p:spPr>
          <a:xfrm>
            <a:off x="-30240" y="2073240"/>
            <a:ext cx="9361440" cy="47671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00080" y="189720"/>
            <a:ext cx="88977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data 4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n silico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alysis of canonical pathways and functions. The lists of differentially represented proteins in HFD+T2 vs HFD were input into the IPA platform (Ingenuity® Systems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www.ingenuity.co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for the identification of canonical pathways and functions differing between HFD+T2 and HFD gastrocnemius muscle mitochondria. Over-represented canonical pathways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functions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r HFD+T2 vs. HFD deregulated proteins are represented in bar plots by their statistical score (negative logarithm to the base 10 of B-H correct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value) with a threshold of 1.3 (yellow straight line). The ratio between deregulated and all proteins of a pathway is also reported (yellow not straight line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8"/>
          <p:cNvSpPr/>
          <p:nvPr/>
        </p:nvSpPr>
        <p:spPr>
          <a:xfrm>
            <a:off x="42840" y="1611360"/>
            <a:ext cx="6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rcRect l="5527" t="0" r="1770" b="0"/>
          <a:stretch/>
        </p:blipFill>
        <p:spPr>
          <a:xfrm>
            <a:off x="0" y="1382760"/>
            <a:ext cx="9144000" cy="5424480"/>
          </a:xfrm>
          <a:prstGeom prst="rect">
            <a:avLst/>
          </a:prstGeom>
          <a:ln w="0">
            <a:noFill/>
          </a:ln>
        </p:spPr>
      </p:pic>
      <p:sp>
        <p:nvSpPr>
          <p:cNvPr id="45" name="Text Box 58"/>
          <p:cNvSpPr/>
          <p:nvPr/>
        </p:nvSpPr>
        <p:spPr>
          <a:xfrm>
            <a:off x="42840" y="954000"/>
            <a:ext cx="6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7-19T10:56:22Z</dcterms:created>
  <dc:creator>DSBA</dc:creator>
  <dc:description/>
  <dc:language>en-US</dc:language>
  <cp:lastModifiedBy>DSBA</cp:lastModifiedBy>
  <dcterms:modified xsi:type="dcterms:W3CDTF">2018-01-25T12:12:21Z</dcterms:modified>
  <cp:revision>6</cp:revision>
  <dc:subject/>
  <dc:title>Diapositiva 1</dc:title>
</cp:coreProperties>
</file>